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54"/>
    <p:restoredTop sz="94674"/>
  </p:normalViewPr>
  <p:slideViewPr>
    <p:cSldViewPr snapToGrid="0" snapToObjects="1">
      <p:cViewPr>
        <p:scale>
          <a:sx n="125" d="100"/>
          <a:sy n="125" d="100"/>
        </p:scale>
        <p:origin x="-186" y="-2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86216B1-BD1A-7047-8AF2-7690132C06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7054C1FB-E433-1D4B-9C5F-DAB6FED841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791EBA4-46C2-EA42-B619-C53D9AD33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C9874-F59F-A240-8677-3A32DBF19643}" type="datetimeFigureOut">
              <a:rPr lang="en-US" smtClean="0"/>
              <a:t>11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12E040E-0C6E-7C4D-8A37-DE4F6D419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1E9156B-07F2-7747-BE5E-89A4365CE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8BF2D-4A72-5A4A-9BA5-96AB035CE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498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56AF390-7A06-5245-86CA-0CE054126B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3241BB6B-9E7B-A640-BE84-666D3B182B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94FA394-BE61-1C42-A92C-02E3ABD33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C9874-F59F-A240-8677-3A32DBF19643}" type="datetimeFigureOut">
              <a:rPr lang="en-US" smtClean="0"/>
              <a:t>11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AC68002-E7E3-EF4B-B0AF-B50AFEC07F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64FD917-E6A9-BF46-B346-1C4FED0317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8BF2D-4A72-5A4A-9BA5-96AB035CE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315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D51BBAC7-D8A3-534D-93EF-E32973792F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C883A657-FC1E-FA41-BA0F-1338AB98BF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E51F740-E94D-6E4F-AFCE-82ABA2132F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C9874-F59F-A240-8677-3A32DBF19643}" type="datetimeFigureOut">
              <a:rPr lang="en-US" smtClean="0"/>
              <a:t>11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1F90363-B432-C04B-AF29-EF377C4F92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30AD954-C1BF-0448-B1E4-9E3EAA702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8BF2D-4A72-5A4A-9BA5-96AB035CE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036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5508DB0-C94B-8245-8C0B-B8FB3ECEF8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A76228F-DE91-554B-84E7-E51F8B0778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501A76B-FA0C-7F4C-A0F1-4E9C548D4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C9874-F59F-A240-8677-3A32DBF19643}" type="datetimeFigureOut">
              <a:rPr lang="en-US" smtClean="0"/>
              <a:t>11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8321F2C-415C-4B45-ACB4-4C119A6DCE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EDD779B-4AC3-5E40-844C-CA50C4A8A8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8BF2D-4A72-5A4A-9BA5-96AB035CE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141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FF56337-32B1-544A-9589-880F118328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8D954C5-6B12-4B45-BF6D-AB0D12D1AF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6049DF4-D62E-4F4B-BFC5-E9ADF4FDE7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C9874-F59F-A240-8677-3A32DBF19643}" type="datetimeFigureOut">
              <a:rPr lang="en-US" smtClean="0"/>
              <a:t>11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27AE387-3495-564C-824C-14C571F46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D69AB91-F0DD-B544-8D53-B06C2B48B1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8BF2D-4A72-5A4A-9BA5-96AB035CE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881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1BF9593-D09A-EC40-ABE7-D9A1C42CA6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BC6160E-D508-8E41-B570-E421468F2F3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7F3D870-6270-9E4E-851F-24D4DC780C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222B1772-B504-5B40-B8D5-25C176843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C9874-F59F-A240-8677-3A32DBF19643}" type="datetimeFigureOut">
              <a:rPr lang="en-US" smtClean="0"/>
              <a:t>11/4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709A25AD-1410-7F4E-A3F7-E70F6111B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6725FFA-1E92-A446-995E-FE4511F1E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8BF2D-4A72-5A4A-9BA5-96AB035CE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996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6AAF3B6-1DEF-4740-A45E-6797787830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AACDD9C-3088-3748-B530-991B879C6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7D090534-C56D-4649-BBF5-CF5FBCC3ED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307F34F9-39BD-3843-A1D6-6C6EE04E46C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27D6BF92-8EBF-0840-965D-FBE79A1A05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1214847D-0CA7-7B46-B663-5CC784944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C9874-F59F-A240-8677-3A32DBF19643}" type="datetimeFigureOut">
              <a:rPr lang="en-US" smtClean="0"/>
              <a:t>11/4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43A21E09-7119-724A-A321-7FB130704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40A3A56A-DC89-6A40-9B78-9860C05F54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8BF2D-4A72-5A4A-9BA5-96AB035CE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62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2DFB329-2A0E-E44C-8891-50B473B1A6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C8E7C61F-87ED-5B4B-AF41-4630AD74D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C9874-F59F-A240-8677-3A32DBF19643}" type="datetimeFigureOut">
              <a:rPr lang="en-US" smtClean="0"/>
              <a:t>11/4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1CAE36DB-70CB-6E4C-B677-D82BEC378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97C23592-EB2D-254B-9404-E700D5E2B8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8BF2D-4A72-5A4A-9BA5-96AB035CE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841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2F334053-4FB9-CD49-866B-D1D9D2AC6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C9874-F59F-A240-8677-3A32DBF19643}" type="datetimeFigureOut">
              <a:rPr lang="en-US" smtClean="0"/>
              <a:t>11/4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70ADCDAC-E0BC-0145-8D13-CFE479026A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CADDE468-EFA2-3245-9EF4-32CF67C28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8BF2D-4A72-5A4A-9BA5-96AB035CE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0012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56E3959-C2EF-8E45-82D8-3540B8B2E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9D2C2D4-3C78-884C-B360-596F35B703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CE417F6C-3417-8742-9875-EBEECC21A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BB7E36A-9F56-8A44-BF7F-A458EFBA98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C9874-F59F-A240-8677-3A32DBF19643}" type="datetimeFigureOut">
              <a:rPr lang="en-US" smtClean="0"/>
              <a:t>11/4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45F9C0F-574C-FB40-88FC-99DEABEA3E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2F5AB4E-9DC1-564D-A937-2ED13E39F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8BF2D-4A72-5A4A-9BA5-96AB035CE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716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2AE6E5C-CABC-B84F-9FCB-BBE891B708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6161D421-1BD0-104E-8B14-8608CDBF9C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6D3A2940-6929-EA4C-9AA5-97A6BE5107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32F549A-9A83-6B4A-9EE4-E26FE6E754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C9874-F59F-A240-8677-3A32DBF19643}" type="datetimeFigureOut">
              <a:rPr lang="en-US" smtClean="0"/>
              <a:t>11/4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672289FA-47F9-2C4F-8228-2C26F92B1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DE84EA24-55A2-1F4A-8D5E-7FD51D595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E8BF2D-4A72-5A4A-9BA5-96AB035CE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383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A65B96FC-F94D-074C-96B4-E4B200079E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CC0724D-12A8-EC48-B451-3E957558FB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982E787-38EC-E040-9D88-C2E2FA122C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C9874-F59F-A240-8677-3A32DBF19643}" type="datetimeFigureOut">
              <a:rPr lang="en-US" smtClean="0"/>
              <a:t>11/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CB5E1D6-CF27-2442-B91A-82D259AE43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D186D2A-333A-644E-B5A3-501DE35CA7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E8BF2D-4A72-5A4A-9BA5-96AB035CE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526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A68A0712-6754-B949-BD72-2E5897A7228C}"/>
              </a:ext>
            </a:extLst>
          </p:cNvPr>
          <p:cNvSpPr txBox="1"/>
          <p:nvPr/>
        </p:nvSpPr>
        <p:spPr>
          <a:xfrm>
            <a:off x="3867429" y="3403790"/>
            <a:ext cx="9124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47004965-5926-6642-9E6D-18B8AFEDDE6B}"/>
              </a:ext>
            </a:extLst>
          </p:cNvPr>
          <p:cNvSpPr txBox="1"/>
          <p:nvPr/>
        </p:nvSpPr>
        <p:spPr>
          <a:xfrm>
            <a:off x="4230328" y="3031074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6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C86D0757-ADB1-B042-AF99-9C15007F5AE9}"/>
              </a:ext>
            </a:extLst>
          </p:cNvPr>
          <p:cNvSpPr txBox="1"/>
          <p:nvPr/>
        </p:nvSpPr>
        <p:spPr>
          <a:xfrm rot="16200000">
            <a:off x="4667096" y="2518420"/>
            <a:ext cx="7630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61AD70FE-7E8A-4144-BCE6-F79F77D2793C}"/>
              </a:ext>
            </a:extLst>
          </p:cNvPr>
          <p:cNvSpPr txBox="1"/>
          <p:nvPr/>
        </p:nvSpPr>
        <p:spPr>
          <a:xfrm rot="16200000">
            <a:off x="5193855" y="2614775"/>
            <a:ext cx="5517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MZ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DEDB31F4-3B51-B74F-B4CA-F3F3B9501D21}"/>
              </a:ext>
            </a:extLst>
          </p:cNvPr>
          <p:cNvSpPr txBox="1"/>
          <p:nvPr/>
        </p:nvSpPr>
        <p:spPr>
          <a:xfrm rot="16200000">
            <a:off x="5221971" y="2236259"/>
            <a:ext cx="13035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X-866 (1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7F1C5753-415E-C24D-A368-C0E87D5B31DA}"/>
              </a:ext>
            </a:extLst>
          </p:cNvPr>
          <p:cNvSpPr txBox="1"/>
          <p:nvPr/>
        </p:nvSpPr>
        <p:spPr>
          <a:xfrm rot="16200000">
            <a:off x="5372500" y="1966688"/>
            <a:ext cx="18742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MZ + PX-866 (1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A0B89BCB-FB0D-1342-AF8A-EFF451F09497}"/>
              </a:ext>
            </a:extLst>
          </p:cNvPr>
          <p:cNvSpPr txBox="1"/>
          <p:nvPr/>
        </p:nvSpPr>
        <p:spPr>
          <a:xfrm>
            <a:off x="5471265" y="850346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98G</a:t>
            </a:r>
          </a:p>
        </p:txBody>
      </p:sp>
      <p:pic>
        <p:nvPicPr>
          <p:cNvPr id="17" name="Picture 12">
            <a:extLst>
              <a:ext uri="{FF2B5EF4-FFF2-40B4-BE49-F238E27FC236}">
                <a16:creationId xmlns:a16="http://schemas.microsoft.com/office/drawing/2014/main" xmlns="" id="{4BA9EAD1-E57B-874E-B58C-5F2208A3BBD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9858" y="3418618"/>
            <a:ext cx="1776172" cy="30889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" name="Picture 14">
            <a:extLst>
              <a:ext uri="{FF2B5EF4-FFF2-40B4-BE49-F238E27FC236}">
                <a16:creationId xmlns:a16="http://schemas.microsoft.com/office/drawing/2014/main" xmlns="" id="{EEE72254-2991-6240-876A-C4207C149FA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9858" y="3070485"/>
            <a:ext cx="1776172" cy="2693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A8ABFC02-5C10-F447-BC06-0C1BBB8722D7}"/>
              </a:ext>
            </a:extLst>
          </p:cNvPr>
          <p:cNvSpPr txBox="1"/>
          <p:nvPr/>
        </p:nvSpPr>
        <p:spPr>
          <a:xfrm>
            <a:off x="700391" y="4513633"/>
            <a:ext cx="110648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dirty="0"/>
              <a:t>T98G cells were treated with PX-866 or TMZ alone or in combination for 24h and then total protein was isolated. p62 protein levels were examined by western blotting, and GAPDH was used as a loading control. </a:t>
            </a:r>
          </a:p>
        </p:txBody>
      </p:sp>
    </p:spTree>
    <p:extLst>
      <p:ext uri="{BB962C8B-B14F-4D97-AF65-F5344CB8AC3E}">
        <p14:creationId xmlns:p14="http://schemas.microsoft.com/office/powerpoint/2010/main" val="135756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61</Words>
  <Application>Microsoft Office PowerPoint</Application>
  <PresentationFormat>Custom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USER</cp:lastModifiedBy>
  <cp:revision>5</cp:revision>
  <dcterms:created xsi:type="dcterms:W3CDTF">2019-10-08T22:33:43Z</dcterms:created>
  <dcterms:modified xsi:type="dcterms:W3CDTF">2019-11-03T22:22:20Z</dcterms:modified>
</cp:coreProperties>
</file>